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8814C-FCB5-478D-989C-0AD7D6322CE9}" type="datetimeFigureOut">
              <a:rPr lang="en-AU" smtClean="0"/>
              <a:t>13/10/2020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1A7D2-DADB-456E-9622-51EB31CC4B4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50617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18814C-FCB5-478D-989C-0AD7D6322CE9}" type="datetimeFigureOut">
              <a:rPr lang="en-AU" smtClean="0"/>
              <a:t>13/10/2020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01A7D2-DADB-456E-9622-51EB31CC4B4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74228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4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 hidden="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sz="3600" b="1" smtClean="0">
                <a:solidFill>
                  <a:schemeClr val="accent1">
                    <a:lumMod val="50000"/>
                  </a:schemeClr>
                </a:solidFill>
                <a:latin typeface="+mn-lt"/>
              </a:rPr>
              <a:t>Acute cigarette smoke-induced eQTL affects formyl peptide receptor expression and lung function</a:t>
            </a:r>
            <a:endParaRPr lang="en-AU" sz="3600" b="1" dirty="0">
              <a:solidFill>
                <a:schemeClr val="accent1">
                  <a:lumMod val="50000"/>
                </a:schemeClr>
              </a:solidFill>
              <a:latin typeface="+mn-lt"/>
            </a:endParaRPr>
          </a:p>
        </p:txBody>
      </p:sp>
      <p:pic>
        <p:nvPicPr>
          <p:cNvPr id="3" name="Picture 2"/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67163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Acute cigarette smoke-induced eQTL affects formyl peptide receptor expression and lung function</vt:lpstr>
    </vt:vector>
  </TitlesOfParts>
  <Company>University Western Austral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cute cigarette smoke-induced eQTL affects formyl peptide receptor expression and lung function</dc:title>
  <dc:creator>Anke Van Eekelen</dc:creator>
  <cp:lastModifiedBy>Anke Van Eekelen</cp:lastModifiedBy>
  <cp:revision>1</cp:revision>
  <dcterms:created xsi:type="dcterms:W3CDTF">2020-10-13T02:13:16Z</dcterms:created>
  <dcterms:modified xsi:type="dcterms:W3CDTF">2020-10-13T02:13:16Z</dcterms:modified>
</cp:coreProperties>
</file>